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6" r:id="rId4"/>
    <p:sldId id="268" r:id="rId5"/>
    <p:sldId id="258" r:id="rId6"/>
    <p:sldId id="260" r:id="rId7"/>
    <p:sldId id="261" r:id="rId8"/>
    <p:sldId id="263" r:id="rId9"/>
    <p:sldId id="264" r:id="rId10"/>
    <p:sldId id="269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5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2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/>
              <a:t>Click to edit Master subtitle style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65248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7837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8189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3490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8114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0092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45548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5187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1219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2450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A0F712-7250-4DE9-A3F7-C62258E506FF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6231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A0F712-7250-4DE9-A3F7-C62258E506FF}" type="datetimeFigureOut">
              <a:rPr lang="zh-CN" altLang="en-US" smtClean="0"/>
              <a:t>2022/6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D08F94-144F-4DA4-B5C8-51FE51AC25A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6009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2595" y="1069125"/>
            <a:ext cx="8015845" cy="4007923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853623" y="5550453"/>
            <a:ext cx="812481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1. 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lignment plot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s our mitochondrial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s assembled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Bank ID AB038556.2 of Japanese eels. </a:t>
            </a:r>
            <a:endParaRPr lang="zh-CN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109919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638019" y="6003902"/>
            <a:ext cx="928444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10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ative genomic analysis of the Japanese eel (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sz="1600" i="1">
                <a:latin typeface="Times New Roman" panose="02020603050405020304" pitchFamily="18" charset="0"/>
                <a:cs typeface="Times New Roman" panose="02020603050405020304" pitchFamily="18" charset="0"/>
              </a:rPr>
              <a:t>japonica</a:t>
            </a:r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600">
                <a:latin typeface="Times New Roman" panose="02020603050405020304" pitchFamily="18" charset="0"/>
                <a:cs typeface="Times New Roman" panose="02020603050405020304" pitchFamily="18" charset="0"/>
              </a:rPr>
              <a:t> tarpons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galops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prinoide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arowanas (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leropages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mosu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275008" y="1090815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386188" y="1108398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6500321" y="1399765"/>
            <a:ext cx="4236102" cy="4410844"/>
            <a:chOff x="6500321" y="1399765"/>
            <a:chExt cx="4236102" cy="4410844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l="3404" t="3957" b="3079"/>
            <a:stretch/>
          </p:blipFill>
          <p:spPr>
            <a:xfrm>
              <a:off x="6778304" y="1661375"/>
              <a:ext cx="3958119" cy="3902298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7273614" y="1399765"/>
              <a:ext cx="28280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-genomic Comparison (21,762 gene pairs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8039849" y="5533610"/>
              <a:ext cx="12955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guilla japonica</a:t>
              </a:r>
            </a:p>
          </p:txBody>
        </p:sp>
        <p:sp>
          <p:nvSpPr>
            <p:cNvPr id="11" name="Rectangle 10"/>
            <p:cNvSpPr/>
            <p:nvPr/>
          </p:nvSpPr>
          <p:spPr>
            <a:xfrm rot="16200000">
              <a:off x="5852836" y="3474024"/>
              <a:ext cx="157196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i="1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Scleropages</a:t>
              </a:r>
              <a:r>
                <a:rPr lang="en-US" sz="1200" i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r>
                <a:rPr lang="en-US" sz="1200" i="1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formosus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n-US" sz="1200" dirty="0"/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1275008" y="1399765"/>
            <a:ext cx="4390075" cy="4410843"/>
            <a:chOff x="1275008" y="1399765"/>
            <a:chExt cx="4390075" cy="4410843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3"/>
            <a:srcRect l="2888" t="4570" b="3972"/>
            <a:stretch/>
          </p:blipFill>
          <p:spPr>
            <a:xfrm>
              <a:off x="1551963" y="1687132"/>
              <a:ext cx="4113120" cy="3837905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2133344" y="1399765"/>
              <a:ext cx="282801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-genomic Comparison (23,457 gene pairs)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899579" y="5533609"/>
              <a:ext cx="12955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guilla japonica</a:t>
              </a:r>
            </a:p>
          </p:txBody>
        </p:sp>
        <p:sp>
          <p:nvSpPr>
            <p:cNvPr id="12" name="Rectangle 11"/>
            <p:cNvSpPr/>
            <p:nvPr/>
          </p:nvSpPr>
          <p:spPr>
            <a:xfrm rot="16200000">
              <a:off x="619059" y="3482487"/>
              <a:ext cx="158889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i="1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Megalops</a:t>
              </a:r>
              <a:r>
                <a:rPr lang="en-US" sz="1200" i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r>
                <a:rPr lang="en-US" sz="1200" i="1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cyprinoides</a:t>
              </a:r>
              <a:r>
                <a:rPr lang="en-US" sz="1200" i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5785581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9416" y="301831"/>
            <a:ext cx="5187434" cy="5187434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2611226" y="5596841"/>
            <a:ext cx="676381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2.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rcos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ot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tochondrial genome of Japanese eel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outer to inner circle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rotein-coding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RNA and tRNA; depth of Illumina short-reads; GC content. </a:t>
            </a:r>
            <a:endParaRPr lang="zh-CN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82946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584121" y="5787124"/>
            <a:ext cx="70973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3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lti-platform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panese eel genome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embly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1925" y="695325"/>
            <a:ext cx="8515350" cy="47053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302030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473134" y="6096181"/>
            <a:ext cx="6778444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4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s comparison of Japanese (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japonica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European (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anguilla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eels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2611073" y="189936"/>
            <a:ext cx="5917499" cy="5766395"/>
            <a:chOff x="2578800" y="329786"/>
            <a:chExt cx="5917499" cy="5766395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93" t="4587" b="6617"/>
            <a:stretch/>
          </p:blipFill>
          <p:spPr>
            <a:xfrm>
              <a:off x="3020036" y="637563"/>
              <a:ext cx="5476263" cy="5150841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5020625" y="5788404"/>
              <a:ext cx="14750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guilla japonica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2010376" y="2926051"/>
              <a:ext cx="144462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guilla </a:t>
              </a:r>
              <a:r>
                <a:rPr lang="en-US" sz="1400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guilla</a:t>
              </a:r>
              <a:endPara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800606" y="329786"/>
              <a:ext cx="35906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ter-genomic Comparison (19,457 gene pairs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911158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604615" y="5628659"/>
            <a:ext cx="6840263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5.</a:t>
            </a:r>
            <a:r>
              <a: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notation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ve databases (NR,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rPro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KEGG,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wissProt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KOG).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4211" y="257904"/>
            <a:ext cx="4981070" cy="49810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93749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1873" y="911225"/>
            <a:ext cx="6527007" cy="4351338"/>
          </a:xfrm>
        </p:spPr>
      </p:pic>
      <p:sp>
        <p:nvSpPr>
          <p:cNvPr id="5" name="Rectangle 4"/>
          <p:cNvSpPr/>
          <p:nvPr/>
        </p:nvSpPr>
        <p:spPr>
          <a:xfrm>
            <a:off x="3332039" y="5675518"/>
            <a:ext cx="564667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6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EGG 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function classification. The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s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w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y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cular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ctions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76223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1429" y="581386"/>
            <a:ext cx="4879284" cy="4879284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F54D77D2-6FE2-E983-1769-565DE05E8955}"/>
              </a:ext>
            </a:extLst>
          </p:cNvPr>
          <p:cNvSpPr/>
          <p:nvPr/>
        </p:nvSpPr>
        <p:spPr>
          <a:xfrm>
            <a:off x="3332039" y="5675518"/>
            <a:ext cx="564667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7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OG 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function classification. The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s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w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y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rticular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ctions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310484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67078" y="1165444"/>
            <a:ext cx="6173521" cy="4630141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04765" y="1229990"/>
            <a:ext cx="2791346" cy="2094123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260786" y="5903161"/>
            <a:ext cx="957216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8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ngth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mRNA, CDS, exon, intron and the number of exon in Japanese eel and the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ther species (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anguilla, A. </a:t>
            </a:r>
            <a:r>
              <a:rPr lang="en-US" altLang="zh-CN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strata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L. </a:t>
            </a:r>
            <a:r>
              <a:rPr lang="en-US" altLang="zh-CN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culatus</a:t>
            </a:r>
            <a:r>
              <a:rPr lang="en-US" altLang="zh-CN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. </a:t>
            </a:r>
            <a:r>
              <a:rPr lang="en-US" altLang="zh-CN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prinoides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3689793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828799" y="5914936"/>
            <a:ext cx="8372819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9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s distributions of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tenic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ralogs and orthologs. Ks value distribution is used to identify genome duplication and speciation.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297940" y="1155330"/>
            <a:ext cx="10232572" cy="4559789"/>
            <a:chOff x="1297940" y="1155330"/>
            <a:chExt cx="10232572" cy="4559789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97940" y="1155330"/>
              <a:ext cx="9484360" cy="4559789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10270157" y="1655546"/>
              <a:ext cx="8050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(paralogs)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0201618" y="1849266"/>
              <a:ext cx="8050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(paralogs)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0725420" y="2042986"/>
              <a:ext cx="8050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(paralogs)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0193653" y="2236706"/>
              <a:ext cx="7938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(</a:t>
              </a:r>
              <a:r>
                <a:rPr lang="en-US" sz="1200" dirty="0" err="1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orthlogs</a:t>
              </a:r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)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0217937" y="2430426"/>
              <a:ext cx="7938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(</a:t>
              </a:r>
              <a:r>
                <a:rPr lang="en-US" sz="1200" dirty="0" err="1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orthlogs</a:t>
              </a:r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0218603" y="2624146"/>
              <a:ext cx="7938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(</a:t>
              </a:r>
              <a:r>
                <a:rPr lang="en-US" sz="1200" dirty="0" err="1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orthlogs</a:t>
              </a:r>
              <a:r>
                <a: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3038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75</TotalTime>
  <Words>305</Words>
  <Application>Microsoft Office PowerPoint</Application>
  <PresentationFormat>Widescreen</PresentationFormat>
  <Paragraphs>27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等线</vt:lpstr>
      <vt:lpstr>等线 Light</vt:lpstr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 Hongbo</dc:creator>
  <cp:lastModifiedBy>Wong Chris K C</cp:lastModifiedBy>
  <cp:revision>34</cp:revision>
  <dcterms:created xsi:type="dcterms:W3CDTF">2022-04-27T06:36:12Z</dcterms:created>
  <dcterms:modified xsi:type="dcterms:W3CDTF">2022-06-22T02:23:13Z</dcterms:modified>
</cp:coreProperties>
</file>